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</p:sldIdLst>
  <p:sldSz cx="9359900" cy="12599988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9" userDrawn="1">
          <p15:clr>
            <a:srgbClr val="A4A3A4"/>
          </p15:clr>
        </p15:guide>
        <p15:guide id="2" pos="2948" userDrawn="1">
          <p15:clr>
            <a:srgbClr val="A4A3A4"/>
          </p15:clr>
        </p15:guide>
        <p15:guide id="3" pos="27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2386" y="67"/>
      </p:cViewPr>
      <p:guideLst>
        <p:guide orient="horz" pos="3969"/>
        <p:guide pos="2948"/>
        <p:guide pos="27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01993" y="2062083"/>
            <a:ext cx="7955915" cy="4386662"/>
          </a:xfrm>
        </p:spPr>
        <p:txBody>
          <a:bodyPr anchor="b"/>
          <a:lstStyle>
            <a:lvl1pPr algn="ctr">
              <a:defRPr sz="6142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9988" y="6617911"/>
            <a:ext cx="7019925" cy="3042080"/>
          </a:xfrm>
        </p:spPr>
        <p:txBody>
          <a:bodyPr/>
          <a:lstStyle>
            <a:lvl1pPr marL="0" indent="0" algn="ctr">
              <a:buNone/>
              <a:defRPr sz="2457"/>
            </a:lvl1pPr>
            <a:lvl2pPr marL="467990" indent="0" algn="ctr">
              <a:buNone/>
              <a:defRPr sz="2047"/>
            </a:lvl2pPr>
            <a:lvl3pPr marL="935980" indent="0" algn="ctr">
              <a:buNone/>
              <a:defRPr sz="1842"/>
            </a:lvl3pPr>
            <a:lvl4pPr marL="1403970" indent="0" algn="ctr">
              <a:buNone/>
              <a:defRPr sz="1638"/>
            </a:lvl4pPr>
            <a:lvl5pPr marL="1871960" indent="0" algn="ctr">
              <a:buNone/>
              <a:defRPr sz="1638"/>
            </a:lvl5pPr>
            <a:lvl6pPr marL="2339950" indent="0" algn="ctr">
              <a:buNone/>
              <a:defRPr sz="1638"/>
            </a:lvl6pPr>
            <a:lvl7pPr marL="2807940" indent="0" algn="ctr">
              <a:buNone/>
              <a:defRPr sz="1638"/>
            </a:lvl7pPr>
            <a:lvl8pPr marL="3275929" indent="0" algn="ctr">
              <a:buNone/>
              <a:defRPr sz="1638"/>
            </a:lvl8pPr>
            <a:lvl9pPr marL="3743919" indent="0" algn="ctr">
              <a:buNone/>
              <a:defRPr sz="1638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3826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4591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98179" y="670833"/>
            <a:ext cx="2018228" cy="1067790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3493" y="670833"/>
            <a:ext cx="5937687" cy="1067790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6486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3825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8619" y="3141251"/>
            <a:ext cx="8072914" cy="5241244"/>
          </a:xfrm>
        </p:spPr>
        <p:txBody>
          <a:bodyPr anchor="b"/>
          <a:lstStyle>
            <a:lvl1pPr>
              <a:defRPr sz="6142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8619" y="8432079"/>
            <a:ext cx="8072914" cy="2756246"/>
          </a:xfrm>
        </p:spPr>
        <p:txBody>
          <a:bodyPr/>
          <a:lstStyle>
            <a:lvl1pPr marL="0" indent="0">
              <a:buNone/>
              <a:defRPr sz="2457">
                <a:solidFill>
                  <a:schemeClr val="tx1"/>
                </a:solidFill>
              </a:defRPr>
            </a:lvl1pPr>
            <a:lvl2pPr marL="467990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2pPr>
            <a:lvl3pPr marL="935980" indent="0">
              <a:buNone/>
              <a:defRPr sz="1842">
                <a:solidFill>
                  <a:schemeClr val="tx1">
                    <a:tint val="75000"/>
                  </a:schemeClr>
                </a:solidFill>
              </a:defRPr>
            </a:lvl3pPr>
            <a:lvl4pPr marL="140397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4pPr>
            <a:lvl5pPr marL="187196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5pPr>
            <a:lvl6pPr marL="233995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6pPr>
            <a:lvl7pPr marL="280794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7pPr>
            <a:lvl8pPr marL="3275929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8pPr>
            <a:lvl9pPr marL="3743919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2228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3493" y="3354163"/>
            <a:ext cx="3977958" cy="799457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8449" y="3354163"/>
            <a:ext cx="3977958" cy="799457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4490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670836"/>
            <a:ext cx="8072914" cy="243541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4713" y="3088748"/>
            <a:ext cx="3959676" cy="1513748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4713" y="4602496"/>
            <a:ext cx="3959676" cy="676957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38450" y="3088748"/>
            <a:ext cx="3979177" cy="1513748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38450" y="4602496"/>
            <a:ext cx="3979177" cy="676957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717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2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8181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839999"/>
            <a:ext cx="3018811" cy="2939997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79177" y="1814168"/>
            <a:ext cx="4738449" cy="8954158"/>
          </a:xfrm>
        </p:spPr>
        <p:txBody>
          <a:bodyPr/>
          <a:lstStyle>
            <a:lvl1pPr>
              <a:defRPr sz="3276"/>
            </a:lvl1pPr>
            <a:lvl2pPr>
              <a:defRPr sz="2866"/>
            </a:lvl2pPr>
            <a:lvl3pPr>
              <a:defRPr sz="2457"/>
            </a:lvl3pPr>
            <a:lvl4pPr>
              <a:defRPr sz="2047"/>
            </a:lvl4pPr>
            <a:lvl5pPr>
              <a:defRPr sz="2047"/>
            </a:lvl5pPr>
            <a:lvl6pPr>
              <a:defRPr sz="2047"/>
            </a:lvl6pPr>
            <a:lvl7pPr>
              <a:defRPr sz="2047"/>
            </a:lvl7pPr>
            <a:lvl8pPr>
              <a:defRPr sz="2047"/>
            </a:lvl8pPr>
            <a:lvl9pPr>
              <a:defRPr sz="204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779996"/>
            <a:ext cx="3018811" cy="7002911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0226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839999"/>
            <a:ext cx="3018811" cy="2939997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79177" y="1814168"/>
            <a:ext cx="4738449" cy="8954158"/>
          </a:xfrm>
        </p:spPr>
        <p:txBody>
          <a:bodyPr anchor="t"/>
          <a:lstStyle>
            <a:lvl1pPr marL="0" indent="0">
              <a:buNone/>
              <a:defRPr sz="3276"/>
            </a:lvl1pPr>
            <a:lvl2pPr marL="467990" indent="0">
              <a:buNone/>
              <a:defRPr sz="2866"/>
            </a:lvl2pPr>
            <a:lvl3pPr marL="935980" indent="0">
              <a:buNone/>
              <a:defRPr sz="2457"/>
            </a:lvl3pPr>
            <a:lvl4pPr marL="1403970" indent="0">
              <a:buNone/>
              <a:defRPr sz="2047"/>
            </a:lvl4pPr>
            <a:lvl5pPr marL="1871960" indent="0">
              <a:buNone/>
              <a:defRPr sz="2047"/>
            </a:lvl5pPr>
            <a:lvl6pPr marL="2339950" indent="0">
              <a:buNone/>
              <a:defRPr sz="2047"/>
            </a:lvl6pPr>
            <a:lvl7pPr marL="2807940" indent="0">
              <a:buNone/>
              <a:defRPr sz="2047"/>
            </a:lvl7pPr>
            <a:lvl8pPr marL="3275929" indent="0">
              <a:buNone/>
              <a:defRPr sz="2047"/>
            </a:lvl8pPr>
            <a:lvl9pPr marL="3743919" indent="0">
              <a:buNone/>
              <a:defRPr sz="2047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779996"/>
            <a:ext cx="3018811" cy="7002911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9135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3493" y="670836"/>
            <a:ext cx="8072914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3493" y="3354163"/>
            <a:ext cx="8072914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3493" y="11678325"/>
            <a:ext cx="2105978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894DF-4A4A-40F7-8DC6-58BFAA82F4B4}" type="datetimeFigureOut">
              <a:rPr lang="ko-KR" altLang="en-US" smtClean="0"/>
              <a:pPr/>
              <a:t>2015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00467" y="11678325"/>
            <a:ext cx="315896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610429" y="11678325"/>
            <a:ext cx="2105978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0B6D4-4B9A-459B-B396-56D51A16E79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9820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35980" rtl="0" eaLnBrk="1" latinLnBrk="1" hangingPunct="1">
        <a:lnSpc>
          <a:spcPct val="90000"/>
        </a:lnSpc>
        <a:spcBef>
          <a:spcPct val="0"/>
        </a:spcBef>
        <a:buNone/>
        <a:defRPr sz="45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3995" indent="-233995" algn="l" defTabSz="935980" rtl="0" eaLnBrk="1" latinLnBrk="1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2866" kern="1200">
          <a:solidFill>
            <a:schemeClr val="tx1"/>
          </a:solidFill>
          <a:latin typeface="+mn-lt"/>
          <a:ea typeface="+mn-ea"/>
          <a:cs typeface="+mn-cs"/>
        </a:defRPr>
      </a:lvl1pPr>
      <a:lvl2pPr marL="701985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457" kern="1200">
          <a:solidFill>
            <a:schemeClr val="tx1"/>
          </a:solidFill>
          <a:latin typeface="+mn-lt"/>
          <a:ea typeface="+mn-ea"/>
          <a:cs typeface="+mn-cs"/>
        </a:defRPr>
      </a:lvl2pPr>
      <a:lvl3pPr marL="1169975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047" kern="1200">
          <a:solidFill>
            <a:schemeClr val="tx1"/>
          </a:solidFill>
          <a:latin typeface="+mn-lt"/>
          <a:ea typeface="+mn-ea"/>
          <a:cs typeface="+mn-cs"/>
        </a:defRPr>
      </a:lvl3pPr>
      <a:lvl4pPr marL="1637965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2105955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573945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3041934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509924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977914" indent="-233995" algn="l" defTabSz="935980" rtl="0" eaLnBrk="1" latinLnBrk="1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935980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3pPr>
      <a:lvl4pPr marL="1403970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1871960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339950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2807940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275929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743919" algn="l" defTabSz="935980" rtl="0" eaLnBrk="1" latinLnBrk="1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3695" y="996611"/>
            <a:ext cx="2448000" cy="1620000"/>
          </a:xfrm>
          <a:prstGeom prst="rect">
            <a:avLst/>
          </a:prstGeom>
        </p:spPr>
      </p:pic>
      <p:pic>
        <p:nvPicPr>
          <p:cNvPr id="20" name="그림 19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997218"/>
            <a:ext cx="2448000" cy="16200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2568619" y="718220"/>
            <a:ext cx="1188000" cy="256480"/>
          </a:xfrm>
          <a:prstGeom prst="rect">
            <a:avLst/>
          </a:prstGeom>
          <a:noFill/>
        </p:spPr>
        <p:txBody>
          <a:bodyPr vert="horz" wrap="square" lIns="0" tIns="0" rIns="0" bIns="0" rtlCol="0">
            <a:spAutoFit/>
          </a:bodyPr>
          <a:lstStyle/>
          <a:p>
            <a:pPr latinLnBrk="0">
              <a:lnSpc>
                <a:spcPts val="1975"/>
              </a:lnSpc>
              <a:tabLst>
                <a:tab pos="143309" algn="l"/>
              </a:tabLst>
              <a:defRPr/>
            </a:pPr>
            <a:r>
              <a:rPr lang="en-US" altLang="ko-KR" sz="130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lang="en-US" altLang="ko-KR" sz="13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837761" y="764867"/>
            <a:ext cx="1548000" cy="200055"/>
          </a:xfrm>
          <a:prstGeom prst="rect">
            <a:avLst/>
          </a:prstGeom>
          <a:noFill/>
        </p:spPr>
        <p:txBody>
          <a:bodyPr vert="horz" wrap="square" lIns="0" tIns="0" rIns="0" bIns="0" rtlCol="0">
            <a:spAutoFit/>
          </a:bodyPr>
          <a:lstStyle/>
          <a:p>
            <a:pPr latinLnBrk="0">
              <a:tabLst>
                <a:tab pos="223133" algn="l"/>
              </a:tabLst>
              <a:defRPr/>
            </a:pPr>
            <a:r>
              <a:rPr lang="en-US" altLang="ko-KR" sz="130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ease Free Survival</a:t>
            </a:r>
            <a:endParaRPr lang="en-US" altLang="ko-KR" sz="13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그림 30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000" y="3735471"/>
            <a:ext cx="2448000" cy="1620000"/>
          </a:xfrm>
          <a:prstGeom prst="rect">
            <a:avLst/>
          </a:prstGeom>
        </p:spPr>
      </p:pic>
      <p:pic>
        <p:nvPicPr>
          <p:cNvPr id="32" name="그림 31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3735471"/>
            <a:ext cx="2448000" cy="1620000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1850080" y="2542349"/>
            <a:ext cx="295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/>
              <a:t>0        </a:t>
            </a:r>
            <a:r>
              <a:rPr lang="en-US" altLang="ko-KR" sz="1200" smtClean="0"/>
              <a:t>  2            4           </a:t>
            </a:r>
            <a:r>
              <a:rPr lang="en-US" altLang="ko-KR" sz="1200"/>
              <a:t>6     </a:t>
            </a:r>
            <a:r>
              <a:rPr lang="en-US" altLang="ko-KR" sz="1200" smtClean="0"/>
              <a:t>      </a:t>
            </a:r>
            <a:r>
              <a:rPr lang="en-US" altLang="ko-KR" sz="1200"/>
              <a:t>8    </a:t>
            </a:r>
            <a:r>
              <a:rPr lang="en-US" altLang="ko-KR" sz="1200" smtClean="0"/>
              <a:t>       </a:t>
            </a:r>
            <a:r>
              <a:rPr lang="en-US" altLang="ko-KR" sz="1200" dirty="0"/>
              <a:t>10</a:t>
            </a:r>
            <a:endParaRPr lang="ko-KR" altLang="en-US" sz="1200" dirty="0"/>
          </a:p>
        </p:txBody>
      </p:sp>
      <p:sp>
        <p:nvSpPr>
          <p:cNvPr id="23" name="Text Box 84"/>
          <p:cNvSpPr txBox="1">
            <a:spLocks noChangeArrowheads="1"/>
          </p:cNvSpPr>
          <p:nvPr/>
        </p:nvSpPr>
        <p:spPr bwMode="auto">
          <a:xfrm rot="10800000">
            <a:off x="1450938" y="1059272"/>
            <a:ext cx="353943" cy="111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 Rate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235662" y="2778338"/>
            <a:ext cx="2199840" cy="291570"/>
          </a:xfrm>
          <a:prstGeom prst="rect">
            <a:avLst/>
          </a:prstGeom>
          <a:noFill/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137"/>
              </a:lnSpc>
            </a:pP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  </a:t>
            </a: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ration(Unit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Year) </a:t>
            </a:r>
          </a:p>
          <a:p>
            <a:pPr>
              <a:lnSpc>
                <a:spcPts val="1137"/>
              </a:lnSpc>
            </a:pP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642964" y="834698"/>
            <a:ext cx="432000" cy="1828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300"/>
              </a:lnSpc>
            </a:pPr>
            <a:r>
              <a:rPr lang="en-US" altLang="ko-KR" sz="1200" dirty="0"/>
              <a:t>1.0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8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6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4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2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0</a:t>
            </a:r>
            <a:endParaRPr lang="ko-KR" altLang="en-US" sz="1200" dirty="0"/>
          </a:p>
        </p:txBody>
      </p:sp>
      <p:pic>
        <p:nvPicPr>
          <p:cNvPr id="59" name="그림 58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000" y="6497089"/>
            <a:ext cx="2448000" cy="1620000"/>
          </a:xfrm>
          <a:prstGeom prst="rect">
            <a:avLst/>
          </a:prstGeom>
        </p:spPr>
      </p:pic>
      <p:pic>
        <p:nvPicPr>
          <p:cNvPr id="60" name="그림 59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6497089"/>
            <a:ext cx="2448000" cy="1620000"/>
          </a:xfrm>
          <a:prstGeom prst="rect">
            <a:avLst/>
          </a:prstGeom>
        </p:spPr>
      </p:pic>
      <p:pic>
        <p:nvPicPr>
          <p:cNvPr id="61" name="그림 60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000" y="9298600"/>
            <a:ext cx="2448000" cy="1620000"/>
          </a:xfrm>
          <a:prstGeom prst="rect">
            <a:avLst/>
          </a:prstGeom>
        </p:spPr>
      </p:pic>
      <p:pic>
        <p:nvPicPr>
          <p:cNvPr id="62" name="그림 61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9298600"/>
            <a:ext cx="2448000" cy="1620000"/>
          </a:xfrm>
          <a:prstGeom prst="rect">
            <a:avLst/>
          </a:prstGeom>
        </p:spPr>
      </p:pic>
      <p:grpSp>
        <p:nvGrpSpPr>
          <p:cNvPr id="135" name="그룹 134"/>
          <p:cNvGrpSpPr/>
          <p:nvPr/>
        </p:nvGrpSpPr>
        <p:grpSpPr>
          <a:xfrm>
            <a:off x="8018847" y="2084335"/>
            <a:ext cx="659611" cy="507831"/>
            <a:chOff x="2949821" y="2577470"/>
            <a:chExt cx="719943" cy="544051"/>
          </a:xfrm>
        </p:grpSpPr>
        <p:cxnSp>
          <p:nvCxnSpPr>
            <p:cNvPr id="136" name="직선 연결선 135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Box 136"/>
            <p:cNvSpPr txBox="1"/>
            <p:nvPr/>
          </p:nvSpPr>
          <p:spPr>
            <a:xfrm>
              <a:off x="3272250" y="2577470"/>
              <a:ext cx="397514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GG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GA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AA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8" name="직선 연결선 137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직선 연결선 138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0" name="그룹 139"/>
          <p:cNvGrpSpPr/>
          <p:nvPr/>
        </p:nvGrpSpPr>
        <p:grpSpPr>
          <a:xfrm>
            <a:off x="8018841" y="4751433"/>
            <a:ext cx="646787" cy="507831"/>
            <a:chOff x="2949821" y="2577470"/>
            <a:chExt cx="705946" cy="544051"/>
          </a:xfrm>
        </p:grpSpPr>
        <p:cxnSp>
          <p:nvCxnSpPr>
            <p:cNvPr id="141" name="직선 연결선 140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/>
            <p:cNvSpPr txBox="1"/>
            <p:nvPr/>
          </p:nvSpPr>
          <p:spPr>
            <a:xfrm>
              <a:off x="3272250" y="2577470"/>
              <a:ext cx="383517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CC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CT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TT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3" name="직선 연결선 142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직선 연결선 143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그룹 144"/>
          <p:cNvGrpSpPr/>
          <p:nvPr/>
        </p:nvGrpSpPr>
        <p:grpSpPr>
          <a:xfrm>
            <a:off x="8027302" y="7532840"/>
            <a:ext cx="659611" cy="507831"/>
            <a:chOff x="2949821" y="2577470"/>
            <a:chExt cx="719943" cy="544051"/>
          </a:xfrm>
        </p:grpSpPr>
        <p:cxnSp>
          <p:nvCxnSpPr>
            <p:cNvPr id="146" name="직선 연결선 145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146"/>
            <p:cNvSpPr txBox="1"/>
            <p:nvPr/>
          </p:nvSpPr>
          <p:spPr>
            <a:xfrm>
              <a:off x="3272250" y="2577470"/>
              <a:ext cx="397514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AA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AG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GG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8" name="직선 연결선 147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직선 연결선 148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0" name="그룹 149"/>
          <p:cNvGrpSpPr/>
          <p:nvPr/>
        </p:nvGrpSpPr>
        <p:grpSpPr>
          <a:xfrm>
            <a:off x="8027296" y="10453953"/>
            <a:ext cx="646787" cy="507831"/>
            <a:chOff x="2949821" y="2577470"/>
            <a:chExt cx="705946" cy="544051"/>
          </a:xfrm>
        </p:grpSpPr>
        <p:cxnSp>
          <p:nvCxnSpPr>
            <p:cNvPr id="151" name="직선 연결선 150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TextBox 151"/>
            <p:cNvSpPr txBox="1"/>
            <p:nvPr/>
          </p:nvSpPr>
          <p:spPr>
            <a:xfrm>
              <a:off x="3272250" y="2577470"/>
              <a:ext cx="383517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TT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TC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CC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3" name="직선 연결선 152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직선 연결선 153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직사각형 3"/>
          <p:cNvSpPr/>
          <p:nvPr/>
        </p:nvSpPr>
        <p:spPr>
          <a:xfrm>
            <a:off x="541595" y="432000"/>
            <a:ext cx="21945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3EAP 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967591G&gt;A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5270742" y="2559277"/>
            <a:ext cx="295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/>
              <a:t>0        </a:t>
            </a:r>
            <a:r>
              <a:rPr lang="en-US" altLang="ko-KR" sz="1200" smtClean="0"/>
              <a:t>  2            4           </a:t>
            </a:r>
            <a:r>
              <a:rPr lang="en-US" altLang="ko-KR" sz="1200"/>
              <a:t>6     </a:t>
            </a:r>
            <a:r>
              <a:rPr lang="en-US" altLang="ko-KR" sz="1200" smtClean="0"/>
              <a:t>      </a:t>
            </a:r>
            <a:r>
              <a:rPr lang="en-US" altLang="ko-KR" sz="1200"/>
              <a:t>8    </a:t>
            </a:r>
            <a:r>
              <a:rPr lang="en-US" altLang="ko-KR" sz="1200" smtClean="0"/>
              <a:t>       </a:t>
            </a:r>
            <a:r>
              <a:rPr lang="en-US" altLang="ko-KR" sz="1200" dirty="0"/>
              <a:t>10</a:t>
            </a:r>
            <a:endParaRPr lang="ko-KR" altLang="en-US" sz="1200" dirty="0"/>
          </a:p>
        </p:txBody>
      </p:sp>
      <p:sp>
        <p:nvSpPr>
          <p:cNvPr id="158" name="Text Box 84"/>
          <p:cNvSpPr txBox="1">
            <a:spLocks noChangeArrowheads="1"/>
          </p:cNvSpPr>
          <p:nvPr/>
        </p:nvSpPr>
        <p:spPr bwMode="auto">
          <a:xfrm rot="10800000">
            <a:off x="4871600" y="1076200"/>
            <a:ext cx="353943" cy="111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 Rate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5656324" y="2795266"/>
            <a:ext cx="2199840" cy="291570"/>
          </a:xfrm>
          <a:prstGeom prst="rect">
            <a:avLst/>
          </a:prstGeom>
          <a:noFill/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137"/>
              </a:lnSpc>
            </a:pP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  </a:t>
            </a: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ration(Unit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Year) </a:t>
            </a:r>
          </a:p>
          <a:p>
            <a:pPr>
              <a:lnSpc>
                <a:spcPts val="1137"/>
              </a:lnSpc>
            </a:pP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5063626" y="851626"/>
            <a:ext cx="432000" cy="1828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300"/>
              </a:lnSpc>
            </a:pPr>
            <a:r>
              <a:rPr lang="en-US" altLang="ko-KR" sz="1200" dirty="0"/>
              <a:t>1.0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8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6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4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2</a:t>
            </a:r>
          </a:p>
          <a:p>
            <a:pPr>
              <a:lnSpc>
                <a:spcPts val="2300"/>
              </a:lnSpc>
            </a:pPr>
            <a:r>
              <a:rPr lang="en-US" altLang="ko-KR" sz="1200" dirty="0"/>
              <a:t>0.0</a:t>
            </a:r>
            <a:endParaRPr lang="ko-KR" altLang="en-US" sz="1200" dirty="0"/>
          </a:p>
        </p:txBody>
      </p:sp>
      <p:sp>
        <p:nvSpPr>
          <p:cNvPr id="161" name="직사각형 160"/>
          <p:cNvSpPr/>
          <p:nvPr/>
        </p:nvSpPr>
        <p:spPr>
          <a:xfrm>
            <a:off x="540000" y="3204298"/>
            <a:ext cx="27011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NFRSF10B 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1047266 C&gt;T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4896345" y="3483471"/>
            <a:ext cx="3351142" cy="2338199"/>
            <a:chOff x="4922396" y="3314132"/>
            <a:chExt cx="3351142" cy="2338199"/>
          </a:xfrm>
        </p:grpSpPr>
        <p:sp>
          <p:nvSpPr>
            <p:cNvPr id="162" name="TextBox 161"/>
            <p:cNvSpPr txBox="1"/>
            <p:nvPr/>
          </p:nvSpPr>
          <p:spPr>
            <a:xfrm>
              <a:off x="5888557" y="3314132"/>
              <a:ext cx="1548000" cy="20005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tabLst>
                  <a:tab pos="223133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 Free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5321538" y="5124772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64" name="Text Box 84"/>
            <p:cNvSpPr txBox="1">
              <a:spLocks noChangeArrowheads="1"/>
            </p:cNvSpPr>
            <p:nvPr/>
          </p:nvSpPr>
          <p:spPr bwMode="auto">
            <a:xfrm rot="10800000">
              <a:off x="4922396" y="3641695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5707120" y="5360761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5114422" y="3417121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1425531" y="3483471"/>
            <a:ext cx="3351142" cy="2329738"/>
            <a:chOff x="1163054" y="3271797"/>
            <a:chExt cx="3351142" cy="2329738"/>
          </a:xfrm>
        </p:grpSpPr>
        <p:sp>
          <p:nvSpPr>
            <p:cNvPr id="167" name="TextBox 166"/>
            <p:cNvSpPr txBox="1"/>
            <p:nvPr/>
          </p:nvSpPr>
          <p:spPr>
            <a:xfrm>
              <a:off x="2280735" y="3271797"/>
              <a:ext cx="1188000" cy="25648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lnSpc>
                  <a:spcPts val="1975"/>
                </a:lnSpc>
                <a:tabLst>
                  <a:tab pos="143309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1562196" y="5073976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69" name="Text Box 84"/>
            <p:cNvSpPr txBox="1">
              <a:spLocks noChangeArrowheads="1"/>
            </p:cNvSpPr>
            <p:nvPr/>
          </p:nvSpPr>
          <p:spPr bwMode="auto">
            <a:xfrm rot="10800000">
              <a:off x="1163054" y="3590899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1947778" y="5309965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1355080" y="3366325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sp>
        <p:nvSpPr>
          <p:cNvPr id="172" name="직사각형 171"/>
          <p:cNvSpPr/>
          <p:nvPr/>
        </p:nvSpPr>
        <p:spPr>
          <a:xfrm>
            <a:off x="540000" y="5951833"/>
            <a:ext cx="27011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1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ko-KR" sz="1400" dirty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3803300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&gt;G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3" name="그룹 172"/>
          <p:cNvGrpSpPr/>
          <p:nvPr/>
        </p:nvGrpSpPr>
        <p:grpSpPr>
          <a:xfrm>
            <a:off x="1442459" y="6236500"/>
            <a:ext cx="3351142" cy="2341182"/>
            <a:chOff x="1163054" y="3260353"/>
            <a:chExt cx="3351142" cy="2341182"/>
          </a:xfrm>
        </p:grpSpPr>
        <p:sp>
          <p:nvSpPr>
            <p:cNvPr id="174" name="TextBox 173"/>
            <p:cNvSpPr txBox="1"/>
            <p:nvPr/>
          </p:nvSpPr>
          <p:spPr>
            <a:xfrm>
              <a:off x="2280735" y="3260353"/>
              <a:ext cx="1188000" cy="25648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lnSpc>
                  <a:spcPts val="1975"/>
                </a:lnSpc>
                <a:tabLst>
                  <a:tab pos="143309" algn="l"/>
                </a:tabLst>
                <a:defRPr/>
              </a:pPr>
              <a:r>
                <a:rPr lang="en-US" altLang="ko-KR" sz="13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1562196" y="5073976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76" name="Text Box 84"/>
            <p:cNvSpPr txBox="1">
              <a:spLocks noChangeArrowheads="1"/>
            </p:cNvSpPr>
            <p:nvPr/>
          </p:nvSpPr>
          <p:spPr bwMode="auto">
            <a:xfrm rot="10800000">
              <a:off x="1163054" y="3590899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1947778" y="5309965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1355080" y="3366325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179" name="그룹 178"/>
          <p:cNvGrpSpPr/>
          <p:nvPr/>
        </p:nvGrpSpPr>
        <p:grpSpPr>
          <a:xfrm>
            <a:off x="4903831" y="6245292"/>
            <a:ext cx="3351142" cy="2341176"/>
            <a:chOff x="4922396" y="3311155"/>
            <a:chExt cx="3351142" cy="2341176"/>
          </a:xfrm>
        </p:grpSpPr>
        <p:sp>
          <p:nvSpPr>
            <p:cNvPr id="180" name="TextBox 179"/>
            <p:cNvSpPr txBox="1"/>
            <p:nvPr/>
          </p:nvSpPr>
          <p:spPr>
            <a:xfrm>
              <a:off x="5888557" y="3311155"/>
              <a:ext cx="1548000" cy="20005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tabLst>
                  <a:tab pos="223133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 Free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5321538" y="5124772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82" name="Text Box 84"/>
            <p:cNvSpPr txBox="1">
              <a:spLocks noChangeArrowheads="1"/>
            </p:cNvSpPr>
            <p:nvPr/>
          </p:nvSpPr>
          <p:spPr bwMode="auto">
            <a:xfrm rot="10800000">
              <a:off x="4922396" y="3641695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5707120" y="5360761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5114422" y="3417121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sp>
        <p:nvSpPr>
          <p:cNvPr id="185" name="직사각형 184"/>
          <p:cNvSpPr/>
          <p:nvPr/>
        </p:nvSpPr>
        <p:spPr>
          <a:xfrm>
            <a:off x="540000" y="8762889"/>
            <a:ext cx="27011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3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ko-KR" sz="1400" dirty="0" smtClean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2287845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&gt;C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6" name="그룹 185"/>
          <p:cNvGrpSpPr/>
          <p:nvPr/>
        </p:nvGrpSpPr>
        <p:grpSpPr>
          <a:xfrm>
            <a:off x="1417052" y="9045501"/>
            <a:ext cx="3351142" cy="2351688"/>
            <a:chOff x="1163054" y="3249847"/>
            <a:chExt cx="3351142" cy="2351688"/>
          </a:xfrm>
        </p:grpSpPr>
        <p:sp>
          <p:nvSpPr>
            <p:cNvPr id="187" name="TextBox 186"/>
            <p:cNvSpPr txBox="1"/>
            <p:nvPr/>
          </p:nvSpPr>
          <p:spPr>
            <a:xfrm>
              <a:off x="2280735" y="3249847"/>
              <a:ext cx="1188000" cy="25648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lnSpc>
                  <a:spcPts val="1975"/>
                </a:lnSpc>
                <a:tabLst>
                  <a:tab pos="143309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1562196" y="5073976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89" name="Text Box 84"/>
            <p:cNvSpPr txBox="1">
              <a:spLocks noChangeArrowheads="1"/>
            </p:cNvSpPr>
            <p:nvPr/>
          </p:nvSpPr>
          <p:spPr bwMode="auto">
            <a:xfrm rot="10800000">
              <a:off x="1163054" y="3590899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1947778" y="5309965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1355080" y="3366325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192" name="그룹 191"/>
          <p:cNvGrpSpPr/>
          <p:nvPr/>
        </p:nvGrpSpPr>
        <p:grpSpPr>
          <a:xfrm>
            <a:off x="4902525" y="9075541"/>
            <a:ext cx="3351142" cy="2321969"/>
            <a:chOff x="4922396" y="3330362"/>
            <a:chExt cx="3351142" cy="2321969"/>
          </a:xfrm>
        </p:grpSpPr>
        <p:sp>
          <p:nvSpPr>
            <p:cNvPr id="193" name="TextBox 192"/>
            <p:cNvSpPr txBox="1"/>
            <p:nvPr/>
          </p:nvSpPr>
          <p:spPr>
            <a:xfrm>
              <a:off x="5888557" y="3330362"/>
              <a:ext cx="1548000" cy="20005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tabLst>
                  <a:tab pos="223133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 Free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5321538" y="5124772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95" name="Text Box 84"/>
            <p:cNvSpPr txBox="1">
              <a:spLocks noChangeArrowheads="1"/>
            </p:cNvSpPr>
            <p:nvPr/>
          </p:nvSpPr>
          <p:spPr bwMode="auto">
            <a:xfrm rot="10800000">
              <a:off x="4922396" y="3641695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5707120" y="5360761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5114422" y="3417121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sp>
        <p:nvSpPr>
          <p:cNvPr id="198" name="TextBox 197"/>
          <p:cNvSpPr txBox="1"/>
          <p:nvPr/>
        </p:nvSpPr>
        <p:spPr>
          <a:xfrm>
            <a:off x="3411588" y="1146538"/>
            <a:ext cx="9481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9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0x10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-6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7043788" y="1146538"/>
            <a:ext cx="7271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0.05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3589388" y="38516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2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7043788" y="38262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1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576688" y="66456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9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967588" y="66456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57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563988" y="9426938"/>
            <a:ext cx="792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01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954888" y="9426938"/>
            <a:ext cx="9481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5.0x10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-5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6269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000" y="1064954"/>
            <a:ext cx="2448000" cy="1620000"/>
          </a:xfrm>
          <a:prstGeom prst="rect">
            <a:avLst/>
          </a:prstGeom>
        </p:spPr>
      </p:pic>
      <p:pic>
        <p:nvPicPr>
          <p:cNvPr id="3" name="그림 2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1064954"/>
            <a:ext cx="2448000" cy="1620000"/>
          </a:xfrm>
          <a:prstGeom prst="rect">
            <a:avLst/>
          </a:prstGeom>
        </p:spPr>
      </p:pic>
      <p:pic>
        <p:nvPicPr>
          <p:cNvPr id="4" name="그림 3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000" y="3756669"/>
            <a:ext cx="2448000" cy="1620000"/>
          </a:xfrm>
          <a:prstGeom prst="rect">
            <a:avLst/>
          </a:prstGeom>
        </p:spPr>
      </p:pic>
      <p:pic>
        <p:nvPicPr>
          <p:cNvPr id="5" name="그림 4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3756669"/>
            <a:ext cx="2448000" cy="1620000"/>
          </a:xfrm>
          <a:prstGeom prst="rect">
            <a:avLst/>
          </a:prstGeom>
        </p:spPr>
      </p:pic>
      <p:pic>
        <p:nvPicPr>
          <p:cNvPr id="8" name="그림 7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000" y="9241767"/>
            <a:ext cx="2448000" cy="1620000"/>
          </a:xfrm>
          <a:prstGeom prst="rect">
            <a:avLst/>
          </a:prstGeom>
        </p:spPr>
      </p:pic>
      <p:pic>
        <p:nvPicPr>
          <p:cNvPr id="9" name="그림 8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9241767"/>
            <a:ext cx="2448000" cy="1620000"/>
          </a:xfrm>
          <a:prstGeom prst="rect">
            <a:avLst/>
          </a:prstGeom>
        </p:spPr>
      </p:pic>
      <p:sp>
        <p:nvSpPr>
          <p:cNvPr id="92" name="직사각형 91"/>
          <p:cNvSpPr/>
          <p:nvPr/>
        </p:nvSpPr>
        <p:spPr>
          <a:xfrm>
            <a:off x="541595" y="432000"/>
            <a:ext cx="2345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ER2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1256428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&gt;A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3" name="그룹 92"/>
          <p:cNvGrpSpPr/>
          <p:nvPr/>
        </p:nvGrpSpPr>
        <p:grpSpPr>
          <a:xfrm>
            <a:off x="1466944" y="792247"/>
            <a:ext cx="3351142" cy="2351688"/>
            <a:chOff x="1163054" y="3249847"/>
            <a:chExt cx="3351142" cy="2351688"/>
          </a:xfrm>
        </p:grpSpPr>
        <p:sp>
          <p:nvSpPr>
            <p:cNvPr id="94" name="TextBox 93"/>
            <p:cNvSpPr txBox="1"/>
            <p:nvPr/>
          </p:nvSpPr>
          <p:spPr>
            <a:xfrm>
              <a:off x="2280735" y="3249847"/>
              <a:ext cx="1188000" cy="25648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lnSpc>
                  <a:spcPts val="1975"/>
                </a:lnSpc>
                <a:tabLst>
                  <a:tab pos="143309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562196" y="5073976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96" name="Text Box 84"/>
            <p:cNvSpPr txBox="1">
              <a:spLocks noChangeArrowheads="1"/>
            </p:cNvSpPr>
            <p:nvPr/>
          </p:nvSpPr>
          <p:spPr bwMode="auto">
            <a:xfrm rot="10800000">
              <a:off x="1163054" y="3590899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947778" y="5309965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1355080" y="3366325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99" name="그룹 98"/>
          <p:cNvGrpSpPr/>
          <p:nvPr/>
        </p:nvGrpSpPr>
        <p:grpSpPr>
          <a:xfrm>
            <a:off x="4901524" y="837459"/>
            <a:ext cx="3351142" cy="2321969"/>
            <a:chOff x="4922396" y="3330362"/>
            <a:chExt cx="3351142" cy="2321969"/>
          </a:xfrm>
        </p:grpSpPr>
        <p:sp>
          <p:nvSpPr>
            <p:cNvPr id="100" name="TextBox 99"/>
            <p:cNvSpPr txBox="1"/>
            <p:nvPr/>
          </p:nvSpPr>
          <p:spPr>
            <a:xfrm>
              <a:off x="5888557" y="3330362"/>
              <a:ext cx="1548000" cy="20005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tabLst>
                  <a:tab pos="223133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 Free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5321538" y="5124772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02" name="Text Box 84"/>
            <p:cNvSpPr txBox="1">
              <a:spLocks noChangeArrowheads="1"/>
            </p:cNvSpPr>
            <p:nvPr/>
          </p:nvSpPr>
          <p:spPr bwMode="auto">
            <a:xfrm rot="10800000">
              <a:off x="4922396" y="3641695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5707120" y="5360761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5114422" y="3417121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sp>
        <p:nvSpPr>
          <p:cNvPr id="105" name="직사각형 104"/>
          <p:cNvSpPr/>
          <p:nvPr/>
        </p:nvSpPr>
        <p:spPr>
          <a:xfrm>
            <a:off x="541589" y="3204000"/>
            <a:ext cx="22124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. 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NB2L1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3756585</a:t>
            </a:r>
            <a:r>
              <a:rPr lang="en-US" altLang="ko-KR" sz="1400" dirty="0" smtClean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&gt;G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6" name="그룹 105"/>
          <p:cNvGrpSpPr/>
          <p:nvPr/>
        </p:nvGrpSpPr>
        <p:grpSpPr>
          <a:xfrm>
            <a:off x="1466938" y="3484746"/>
            <a:ext cx="3351142" cy="2351688"/>
            <a:chOff x="1163054" y="3249847"/>
            <a:chExt cx="3351142" cy="2351688"/>
          </a:xfrm>
        </p:grpSpPr>
        <p:sp>
          <p:nvSpPr>
            <p:cNvPr id="107" name="TextBox 106"/>
            <p:cNvSpPr txBox="1"/>
            <p:nvPr/>
          </p:nvSpPr>
          <p:spPr>
            <a:xfrm>
              <a:off x="2280735" y="3249847"/>
              <a:ext cx="1188000" cy="25648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lnSpc>
                  <a:spcPts val="1975"/>
                </a:lnSpc>
                <a:tabLst>
                  <a:tab pos="143309" algn="l"/>
                </a:tabLst>
                <a:defRPr/>
              </a:pPr>
              <a:r>
                <a:rPr lang="en-US" altLang="ko-KR" sz="13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1562196" y="5073976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09" name="Text Box 84"/>
            <p:cNvSpPr txBox="1">
              <a:spLocks noChangeArrowheads="1"/>
            </p:cNvSpPr>
            <p:nvPr/>
          </p:nvSpPr>
          <p:spPr bwMode="auto">
            <a:xfrm rot="10800000">
              <a:off x="1163054" y="3590899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947778" y="5309965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355080" y="3366325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118" name="그룹 117"/>
          <p:cNvGrpSpPr/>
          <p:nvPr/>
        </p:nvGrpSpPr>
        <p:grpSpPr>
          <a:xfrm>
            <a:off x="4893046" y="3521485"/>
            <a:ext cx="3351142" cy="2321969"/>
            <a:chOff x="4922396" y="3330362"/>
            <a:chExt cx="3351142" cy="2321969"/>
          </a:xfrm>
        </p:grpSpPr>
        <p:sp>
          <p:nvSpPr>
            <p:cNvPr id="119" name="TextBox 118"/>
            <p:cNvSpPr txBox="1"/>
            <p:nvPr/>
          </p:nvSpPr>
          <p:spPr>
            <a:xfrm>
              <a:off x="5888557" y="3330362"/>
              <a:ext cx="1548000" cy="20005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tabLst>
                  <a:tab pos="223133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 Free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5321538" y="5124772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21" name="Text Box 84"/>
            <p:cNvSpPr txBox="1">
              <a:spLocks noChangeArrowheads="1"/>
            </p:cNvSpPr>
            <p:nvPr/>
          </p:nvSpPr>
          <p:spPr bwMode="auto">
            <a:xfrm rot="10800000">
              <a:off x="4922396" y="3641695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5707120" y="5360761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5114422" y="3417121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sp>
        <p:nvSpPr>
          <p:cNvPr id="124" name="직사각형 123"/>
          <p:cNvSpPr/>
          <p:nvPr/>
        </p:nvSpPr>
        <p:spPr>
          <a:xfrm>
            <a:off x="541583" y="5965400"/>
            <a:ext cx="26127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AMTSL3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11259927</a:t>
            </a:r>
            <a:r>
              <a:rPr lang="en-US" altLang="ko-KR" sz="1400" dirty="0" smtClean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&gt;T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5" name="그림 124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000" y="6514028"/>
            <a:ext cx="2448000" cy="1620000"/>
          </a:xfrm>
          <a:prstGeom prst="rect">
            <a:avLst/>
          </a:prstGeom>
        </p:spPr>
      </p:pic>
      <p:pic>
        <p:nvPicPr>
          <p:cNvPr id="126" name="그림 125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0000" y="6514028"/>
            <a:ext cx="2448000" cy="1620000"/>
          </a:xfrm>
          <a:prstGeom prst="rect">
            <a:avLst/>
          </a:prstGeom>
        </p:spPr>
      </p:pic>
      <p:grpSp>
        <p:nvGrpSpPr>
          <p:cNvPr id="132" name="그룹 131"/>
          <p:cNvGrpSpPr/>
          <p:nvPr/>
        </p:nvGrpSpPr>
        <p:grpSpPr>
          <a:xfrm>
            <a:off x="1441531" y="6240757"/>
            <a:ext cx="3351142" cy="2351688"/>
            <a:chOff x="1163054" y="3249847"/>
            <a:chExt cx="3351142" cy="2351688"/>
          </a:xfrm>
        </p:grpSpPr>
        <p:sp>
          <p:nvSpPr>
            <p:cNvPr id="133" name="TextBox 132"/>
            <p:cNvSpPr txBox="1"/>
            <p:nvPr/>
          </p:nvSpPr>
          <p:spPr>
            <a:xfrm>
              <a:off x="2280735" y="3249847"/>
              <a:ext cx="1188000" cy="25648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lnSpc>
                  <a:spcPts val="1975"/>
                </a:lnSpc>
                <a:tabLst>
                  <a:tab pos="143309" algn="l"/>
                </a:tabLst>
                <a:defRPr/>
              </a:pPr>
              <a:r>
                <a:rPr lang="en-US" altLang="ko-KR" sz="13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1562196" y="5073976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35" name="Text Box 84"/>
            <p:cNvSpPr txBox="1">
              <a:spLocks noChangeArrowheads="1"/>
            </p:cNvSpPr>
            <p:nvPr/>
          </p:nvSpPr>
          <p:spPr bwMode="auto">
            <a:xfrm rot="10800000">
              <a:off x="1163054" y="3590899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947778" y="5309965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355080" y="3366325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138" name="그룹 137"/>
          <p:cNvGrpSpPr/>
          <p:nvPr/>
        </p:nvGrpSpPr>
        <p:grpSpPr>
          <a:xfrm>
            <a:off x="4901505" y="6277496"/>
            <a:ext cx="3351142" cy="2321969"/>
            <a:chOff x="4922396" y="3330362"/>
            <a:chExt cx="3351142" cy="2321969"/>
          </a:xfrm>
        </p:grpSpPr>
        <p:sp>
          <p:nvSpPr>
            <p:cNvPr id="139" name="TextBox 138"/>
            <p:cNvSpPr txBox="1"/>
            <p:nvPr/>
          </p:nvSpPr>
          <p:spPr>
            <a:xfrm>
              <a:off x="5888557" y="3330362"/>
              <a:ext cx="1548000" cy="20005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tabLst>
                  <a:tab pos="223133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 Free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5321538" y="5124772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41" name="Text Box 84"/>
            <p:cNvSpPr txBox="1">
              <a:spLocks noChangeArrowheads="1"/>
            </p:cNvSpPr>
            <p:nvPr/>
          </p:nvSpPr>
          <p:spPr bwMode="auto">
            <a:xfrm rot="10800000">
              <a:off x="4922396" y="3641695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5707120" y="5360761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5114422" y="3417121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sp>
        <p:nvSpPr>
          <p:cNvPr id="144" name="직사각형 143"/>
          <p:cNvSpPr/>
          <p:nvPr/>
        </p:nvSpPr>
        <p:spPr>
          <a:xfrm>
            <a:off x="541577" y="8735300"/>
            <a:ext cx="20778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 latinLnBrk="0"/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D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ko-KR" sz="1400" dirty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3181259</a:t>
            </a:r>
            <a:r>
              <a:rPr lang="en-US" altLang="ko-KR" sz="1400" dirty="0" smtClean="0">
                <a:solidFill>
                  <a:srgbClr val="2B2A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&gt;T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5" name="그룹 144"/>
          <p:cNvGrpSpPr/>
          <p:nvPr/>
        </p:nvGrpSpPr>
        <p:grpSpPr>
          <a:xfrm>
            <a:off x="1466926" y="8992536"/>
            <a:ext cx="3351142" cy="2351688"/>
            <a:chOff x="1163054" y="3249847"/>
            <a:chExt cx="3351142" cy="2351688"/>
          </a:xfrm>
        </p:grpSpPr>
        <p:sp>
          <p:nvSpPr>
            <p:cNvPr id="146" name="TextBox 145"/>
            <p:cNvSpPr txBox="1"/>
            <p:nvPr/>
          </p:nvSpPr>
          <p:spPr>
            <a:xfrm>
              <a:off x="2280735" y="3249847"/>
              <a:ext cx="1188000" cy="25648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lnSpc>
                  <a:spcPts val="1975"/>
                </a:lnSpc>
                <a:tabLst>
                  <a:tab pos="143309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1562196" y="5073976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48" name="Text Box 84"/>
            <p:cNvSpPr txBox="1">
              <a:spLocks noChangeArrowheads="1"/>
            </p:cNvSpPr>
            <p:nvPr/>
          </p:nvSpPr>
          <p:spPr bwMode="auto">
            <a:xfrm rot="10800000">
              <a:off x="1163054" y="3590899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1947778" y="5309965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1355080" y="3366325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151" name="그룹 150"/>
          <p:cNvGrpSpPr/>
          <p:nvPr/>
        </p:nvGrpSpPr>
        <p:grpSpPr>
          <a:xfrm>
            <a:off x="4901499" y="9012341"/>
            <a:ext cx="3351142" cy="2321969"/>
            <a:chOff x="4922396" y="3330362"/>
            <a:chExt cx="3351142" cy="2321969"/>
          </a:xfrm>
        </p:grpSpPr>
        <p:sp>
          <p:nvSpPr>
            <p:cNvPr id="152" name="TextBox 151"/>
            <p:cNvSpPr txBox="1"/>
            <p:nvPr/>
          </p:nvSpPr>
          <p:spPr>
            <a:xfrm>
              <a:off x="5888557" y="3330362"/>
              <a:ext cx="1548000" cy="20005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latinLnBrk="0">
                <a:tabLst>
                  <a:tab pos="223133" algn="l"/>
                </a:tabLst>
                <a:defRPr/>
              </a:pPr>
              <a:r>
                <a:rPr lang="en-US" altLang="ko-KR" sz="130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 Free Survival</a:t>
              </a:r>
              <a:endParaRPr lang="en-US" altLang="ko-KR" sz="13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5321538" y="5124772"/>
              <a:ext cx="29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0        </a:t>
              </a:r>
              <a:r>
                <a:rPr lang="en-US" altLang="ko-KR" sz="1200" smtClean="0"/>
                <a:t>  2            4           </a:t>
              </a:r>
              <a:r>
                <a:rPr lang="en-US" altLang="ko-KR" sz="1200"/>
                <a:t>6     </a:t>
              </a:r>
              <a:r>
                <a:rPr lang="en-US" altLang="ko-KR" sz="1200" smtClean="0"/>
                <a:t>      </a:t>
              </a:r>
              <a:r>
                <a:rPr lang="en-US" altLang="ko-KR" sz="1200"/>
                <a:t>8    </a:t>
              </a:r>
              <a:r>
                <a:rPr lang="en-US" altLang="ko-KR" sz="1200" smtClean="0"/>
                <a:t>       </a:t>
              </a:r>
              <a:r>
                <a:rPr lang="en-US" altLang="ko-KR" sz="1200" dirty="0"/>
                <a:t>10</a:t>
              </a:r>
              <a:endParaRPr lang="ko-KR" altLang="en-US" sz="1200" dirty="0"/>
            </a:p>
          </p:txBody>
        </p:sp>
        <p:sp>
          <p:nvSpPr>
            <p:cNvPr id="154" name="Text Box 84"/>
            <p:cNvSpPr txBox="1">
              <a:spLocks noChangeArrowheads="1"/>
            </p:cNvSpPr>
            <p:nvPr/>
          </p:nvSpPr>
          <p:spPr bwMode="auto">
            <a:xfrm rot="10800000">
              <a:off x="4922396" y="3641695"/>
              <a:ext cx="353943" cy="111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Rate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5707120" y="5360761"/>
              <a:ext cx="2199840" cy="291570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ts val="1137"/>
                </a:lnSpc>
              </a:pP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ation(Unit</a:t>
              </a:r>
              <a:r>
                <a:rPr lang="en-US" altLang="ko-KR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: Year) </a:t>
              </a:r>
            </a:p>
            <a:p>
              <a:pPr>
                <a:lnSpc>
                  <a:spcPts val="1137"/>
                </a:lnSpc>
              </a:pP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5114422" y="3417121"/>
              <a:ext cx="432000" cy="1828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300"/>
                </a:lnSpc>
              </a:pPr>
              <a:r>
                <a:rPr lang="en-US" altLang="ko-KR" sz="1200" dirty="0"/>
                <a:t>1.0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8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6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4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2</a:t>
              </a:r>
            </a:p>
            <a:p>
              <a:pPr>
                <a:lnSpc>
                  <a:spcPts val="2300"/>
                </a:lnSpc>
              </a:pPr>
              <a:r>
                <a:rPr lang="en-US" altLang="ko-KR" sz="1200" dirty="0"/>
                <a:t>0.0</a:t>
              </a:r>
              <a:endParaRPr lang="ko-KR" altLang="en-US" sz="1200" dirty="0"/>
            </a:p>
          </p:txBody>
        </p:sp>
      </p:grpSp>
      <p:grpSp>
        <p:nvGrpSpPr>
          <p:cNvPr id="157" name="그룹 156"/>
          <p:cNvGrpSpPr/>
          <p:nvPr/>
        </p:nvGrpSpPr>
        <p:grpSpPr>
          <a:xfrm>
            <a:off x="8018847" y="2084335"/>
            <a:ext cx="659611" cy="507831"/>
            <a:chOff x="2949821" y="2577470"/>
            <a:chExt cx="719943" cy="544051"/>
          </a:xfrm>
        </p:grpSpPr>
        <p:cxnSp>
          <p:nvCxnSpPr>
            <p:cNvPr id="158" name="직선 연결선 157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TextBox 158"/>
            <p:cNvSpPr txBox="1"/>
            <p:nvPr/>
          </p:nvSpPr>
          <p:spPr>
            <a:xfrm>
              <a:off x="3272250" y="2577470"/>
              <a:ext cx="397514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GG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GA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dirty="0" smtClean="0">
                  <a:latin typeface="Arial" pitchFamily="34" charset="0"/>
                  <a:cs typeface="Arial" pitchFamily="34" charset="0"/>
                </a:rPr>
                <a:t>AA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0" name="직선 연결선 159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직선 연결선 160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4" name="그룹 183"/>
          <p:cNvGrpSpPr/>
          <p:nvPr/>
        </p:nvGrpSpPr>
        <p:grpSpPr>
          <a:xfrm>
            <a:off x="8018841" y="4776833"/>
            <a:ext cx="659611" cy="507831"/>
            <a:chOff x="2949821" y="2577470"/>
            <a:chExt cx="719943" cy="544051"/>
          </a:xfrm>
        </p:grpSpPr>
        <p:cxnSp>
          <p:nvCxnSpPr>
            <p:cNvPr id="185" name="직선 연결선 184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TextBox 185"/>
            <p:cNvSpPr txBox="1"/>
            <p:nvPr/>
          </p:nvSpPr>
          <p:spPr>
            <a:xfrm>
              <a:off x="3272250" y="2577470"/>
              <a:ext cx="397514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TT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TG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GG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7" name="직선 연결선 186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직선 연결선 187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9" name="그룹 188"/>
          <p:cNvGrpSpPr/>
          <p:nvPr/>
        </p:nvGrpSpPr>
        <p:grpSpPr>
          <a:xfrm>
            <a:off x="8027302" y="7558240"/>
            <a:ext cx="646787" cy="507831"/>
            <a:chOff x="2949821" y="2577470"/>
            <a:chExt cx="705946" cy="544051"/>
          </a:xfrm>
        </p:grpSpPr>
        <p:cxnSp>
          <p:nvCxnSpPr>
            <p:cNvPr id="190" name="직선 연결선 189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TextBox 190"/>
            <p:cNvSpPr txBox="1"/>
            <p:nvPr/>
          </p:nvSpPr>
          <p:spPr>
            <a:xfrm>
              <a:off x="3272250" y="2577470"/>
              <a:ext cx="383517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CC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CT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TT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2" name="직선 연결선 191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직선 연결선 192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4" name="그룹 193"/>
          <p:cNvGrpSpPr/>
          <p:nvPr/>
        </p:nvGrpSpPr>
        <p:grpSpPr>
          <a:xfrm>
            <a:off x="8027296" y="10199953"/>
            <a:ext cx="646787" cy="507831"/>
            <a:chOff x="2949821" y="2577470"/>
            <a:chExt cx="705946" cy="544051"/>
          </a:xfrm>
        </p:grpSpPr>
        <p:cxnSp>
          <p:nvCxnSpPr>
            <p:cNvPr id="195" name="직선 연결선 194"/>
            <p:cNvCxnSpPr/>
            <p:nvPr/>
          </p:nvCxnSpPr>
          <p:spPr>
            <a:xfrm>
              <a:off x="2955497" y="2695357"/>
              <a:ext cx="35363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TextBox 195"/>
            <p:cNvSpPr txBox="1"/>
            <p:nvPr/>
          </p:nvSpPr>
          <p:spPr>
            <a:xfrm>
              <a:off x="3272250" y="2577470"/>
              <a:ext cx="383517" cy="544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CC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CT</a:t>
              </a:r>
              <a:endParaRPr lang="en-US" altLang="ko-KR" sz="900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en-US" altLang="ko-KR" sz="900" smtClean="0">
                  <a:latin typeface="Arial" pitchFamily="34" charset="0"/>
                  <a:cs typeface="Arial" pitchFamily="34" charset="0"/>
                </a:rPr>
                <a:t>TT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7" name="직선 연결선 196"/>
            <p:cNvCxnSpPr/>
            <p:nvPr/>
          </p:nvCxnSpPr>
          <p:spPr>
            <a:xfrm>
              <a:off x="2950106" y="2951898"/>
              <a:ext cx="353635" cy="0"/>
            </a:xfrm>
            <a:prstGeom prst="line">
              <a:avLst/>
            </a:prstGeom>
            <a:ln w="22225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직선 연결선 197"/>
            <p:cNvCxnSpPr/>
            <p:nvPr/>
          </p:nvCxnSpPr>
          <p:spPr>
            <a:xfrm>
              <a:off x="2949821" y="2822292"/>
              <a:ext cx="353635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2" name="TextBox 81"/>
          <p:cNvSpPr txBox="1"/>
          <p:nvPr/>
        </p:nvSpPr>
        <p:spPr>
          <a:xfrm>
            <a:off x="3411588" y="11465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7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954888" y="11465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41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398888" y="38770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2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942188" y="38770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14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398888" y="66202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1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942188" y="66202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4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398888" y="93634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3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6942188" y="9363438"/>
            <a:ext cx="709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P </a:t>
            </a:r>
            <a:r>
              <a:rPr lang="en-US" altLang="ko-KR" sz="12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=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0.05</a:t>
            </a:r>
            <a:endParaRPr lang="ko-KR" altLang="en-US" sz="12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7214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501125" y="888900"/>
            <a:ext cx="7718425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S1 Fig. 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Kaplan-Meier plots of overall survival and disease-free survival according to genotypes: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CD3EAP  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rs967591G&gt;A, A);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TNFRSF10B  </a:t>
            </a:r>
            <a:r>
              <a:rPr lang="en-US" altLang="ko-KR" sz="2000" dirty="0" smtClean="0">
                <a:solidFill>
                  <a:srgbClr val="000000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rs1047266 C&gt;T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, B);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AKT1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  </a:t>
            </a:r>
            <a:r>
              <a:rPr lang="en-US" altLang="ko-KR" sz="2000" dirty="0" smtClean="0">
                <a:solidFill>
                  <a:srgbClr val="2B2A29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rs3803300</a:t>
            </a:r>
            <a:r>
              <a:rPr lang="en-US" altLang="ko-KR" sz="2000" dirty="0" smtClean="0">
                <a:solidFill>
                  <a:srgbClr val="000000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 A&gt;G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, C);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C3 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rs2287845T&gt;C, D);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HOMER2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 </a:t>
            </a:r>
            <a:r>
              <a:rPr lang="en-US" altLang="ko-KR" sz="2000" dirty="0" smtClean="0">
                <a:solidFill>
                  <a:srgbClr val="2B2A29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rs1256428 </a:t>
            </a:r>
            <a:r>
              <a:rPr lang="en-US" altLang="ko-KR" sz="2000" dirty="0" smtClean="0">
                <a:solidFill>
                  <a:srgbClr val="000000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G&gt;A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, E);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GNB2L1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 </a:t>
            </a:r>
            <a:r>
              <a:rPr lang="en-US" altLang="ko-KR" sz="2000" dirty="0" smtClean="0">
                <a:solidFill>
                  <a:srgbClr val="2B2A29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rs3756585 </a:t>
            </a:r>
            <a:r>
              <a:rPr lang="en-US" altLang="ko-KR" sz="2000" dirty="0" smtClean="0">
                <a:solidFill>
                  <a:srgbClr val="000000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T&gt;G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, F);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ADAMTSL3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 </a:t>
            </a:r>
            <a:r>
              <a:rPr lang="en-US" altLang="ko-KR" sz="2000" dirty="0" smtClean="0">
                <a:solidFill>
                  <a:srgbClr val="2B2A29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rs11259927 </a:t>
            </a:r>
            <a:r>
              <a:rPr lang="en-US" altLang="ko-KR" sz="2000" dirty="0" smtClean="0">
                <a:solidFill>
                  <a:srgbClr val="000000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C&gt;T, G); 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and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CD3D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  </a:t>
            </a:r>
            <a:r>
              <a:rPr lang="en-US" altLang="ko-KR" sz="2000" dirty="0" smtClean="0">
                <a:solidFill>
                  <a:srgbClr val="2B2A29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rs3181259 </a:t>
            </a:r>
            <a:r>
              <a:rPr lang="en-US" altLang="ko-KR" sz="2000" dirty="0" smtClean="0">
                <a:solidFill>
                  <a:srgbClr val="000000"/>
                </a:solidFill>
                <a:latin typeface="Tahoma" pitchFamily="34" charset="0"/>
                <a:ea typeface="Tahoma" pitchFamily="34" charset="0"/>
                <a:cs typeface="Tahoma" pitchFamily="34" charset="0"/>
              </a:rPr>
              <a:t>C&gt;T, H). </a:t>
            </a:r>
            <a:r>
              <a:rPr lang="en-US" altLang="ko-KR" sz="2000" i="1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P </a:t>
            </a:r>
            <a:r>
              <a:rPr lang="en-US" altLang="ko-KR" sz="2000" dirty="0" smtClean="0">
                <a:latin typeface="Tahoma" pitchFamily="34" charset="0"/>
                <a:ea typeface="Tahoma" pitchFamily="34" charset="0"/>
                <a:cs typeface="Tahoma" pitchFamily="34" charset="0"/>
              </a:rPr>
              <a:t>values by Log-rank test.</a:t>
            </a:r>
            <a:endParaRPr lang="ko-KR" altLang="en-US" sz="2000" dirty="0">
              <a:latin typeface="Tahoma" pitchFamily="34" charset="0"/>
              <a:cs typeface="Tahoma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4</TotalTime>
  <Words>522</Words>
  <Application>Microsoft Office PowerPoint</Application>
  <PresentationFormat>사용자 지정</PresentationFormat>
  <Paragraphs>209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1" baseType="lpstr">
      <vt:lpstr>Arial Unicode MS</vt:lpstr>
      <vt:lpstr>맑은 고딕</vt:lpstr>
      <vt:lpstr>Arial</vt:lpstr>
      <vt:lpstr>Calibri</vt:lpstr>
      <vt:lpstr>Calibri Light</vt:lpstr>
      <vt:lpstr>Tahoma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장혁</dc:creator>
  <cp:lastModifiedBy>Master</cp:lastModifiedBy>
  <cp:revision>61</cp:revision>
  <dcterms:created xsi:type="dcterms:W3CDTF">2014-10-29T05:19:28Z</dcterms:created>
  <dcterms:modified xsi:type="dcterms:W3CDTF">2015-09-10T17:14:38Z</dcterms:modified>
</cp:coreProperties>
</file>